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852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04800" y="4869849"/>
            <a:ext cx="86106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Additional fil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4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ffects on C6 cells from CUR-conditioned medium.  Average hourly mitotic (A) and apoptotic (B) rates were not significantly altered by medium treated with 5 µM CUR for 24 hours (CM).  Also shown are 0 and 5 µM results from Figure 2 for comparison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Additional4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762000"/>
            <a:ext cx="9027566" cy="371802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5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apurna sarma</dc:creator>
  <cp:lastModifiedBy>Michael Eric Geusz</cp:lastModifiedBy>
  <cp:revision>9</cp:revision>
  <dcterms:created xsi:type="dcterms:W3CDTF">2016-02-23T04:09:54Z</dcterms:created>
  <dcterms:modified xsi:type="dcterms:W3CDTF">2016-07-21T03:03:06Z</dcterms:modified>
</cp:coreProperties>
</file>